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handoutMasterIdLst>
    <p:handoutMasterId r:id="rId4"/>
  </p:handoutMasterIdLst>
  <p:sldIdLst>
    <p:sldId id="260" r:id="rId2"/>
  </p:sldIdLst>
  <p:sldSz cx="12960350" cy="21959888"/>
  <p:notesSz cx="6889750" cy="100218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068" autoAdjust="0"/>
    <p:restoredTop sz="94660"/>
  </p:normalViewPr>
  <p:slideViewPr>
    <p:cSldViewPr snapToGrid="0">
      <p:cViewPr>
        <p:scale>
          <a:sx n="48" d="100"/>
          <a:sy n="48" d="100"/>
        </p:scale>
        <p:origin x="-1542" y="240"/>
      </p:cViewPr>
      <p:guideLst>
        <p:guide orient="horz" pos="6916"/>
        <p:guide pos="408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5558" cy="502835"/>
          </a:xfrm>
          <a:prstGeom prst="rect">
            <a:avLst/>
          </a:prstGeom>
        </p:spPr>
        <p:txBody>
          <a:bodyPr vert="horz" lIns="96634" tIns="48317" rIns="96634" bIns="48317" rtlCol="0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3902597" y="0"/>
            <a:ext cx="2985558" cy="502835"/>
          </a:xfrm>
          <a:prstGeom prst="rect">
            <a:avLst/>
          </a:prstGeom>
        </p:spPr>
        <p:txBody>
          <a:bodyPr vert="horz" lIns="96634" tIns="48317" rIns="96634" bIns="48317" rtlCol="0"/>
          <a:lstStyle>
            <a:lvl1pPr algn="r">
              <a:defRPr sz="1300"/>
            </a:lvl1pPr>
          </a:lstStyle>
          <a:p>
            <a:fld id="{0865300D-C0DB-4A38-BD44-A77EA31991B3}" type="datetimeFigureOut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0" y="9519055"/>
            <a:ext cx="2985558" cy="502834"/>
          </a:xfrm>
          <a:prstGeom prst="rect">
            <a:avLst/>
          </a:prstGeom>
        </p:spPr>
        <p:txBody>
          <a:bodyPr vert="horz" lIns="96634" tIns="48317" rIns="96634" bIns="48317" rtlCol="0" anchor="b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3902597" y="9519055"/>
            <a:ext cx="2985558" cy="502834"/>
          </a:xfrm>
          <a:prstGeom prst="rect">
            <a:avLst/>
          </a:prstGeom>
        </p:spPr>
        <p:txBody>
          <a:bodyPr vert="horz" lIns="96634" tIns="48317" rIns="96634" bIns="48317" rtlCol="0" anchor="b"/>
          <a:lstStyle>
            <a:lvl1pPr algn="r">
              <a:defRPr sz="1300"/>
            </a:lvl1pPr>
          </a:lstStyle>
          <a:p>
            <a:fld id="{674C055D-3DDC-4A69-8032-9333AC9DD4D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859915682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5558" cy="502835"/>
          </a:xfrm>
          <a:prstGeom prst="rect">
            <a:avLst/>
          </a:prstGeom>
        </p:spPr>
        <p:txBody>
          <a:bodyPr vert="horz" lIns="96634" tIns="48317" rIns="96634" bIns="48317" rtlCol="0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902597" y="0"/>
            <a:ext cx="2985558" cy="502835"/>
          </a:xfrm>
          <a:prstGeom prst="rect">
            <a:avLst/>
          </a:prstGeom>
        </p:spPr>
        <p:txBody>
          <a:bodyPr vert="horz" lIns="96634" tIns="48317" rIns="96634" bIns="48317" rtlCol="0"/>
          <a:lstStyle>
            <a:lvl1pPr algn="r">
              <a:defRPr sz="1300"/>
            </a:lvl1pPr>
          </a:lstStyle>
          <a:p>
            <a:fld id="{8CBEB62A-5263-4422-9935-2F8A43E720BE}" type="datetimeFigureOut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447925" y="1252538"/>
            <a:ext cx="1993900" cy="33829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34" tIns="48317" rIns="96634" bIns="48317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8975" y="4823034"/>
            <a:ext cx="5511800" cy="3946118"/>
          </a:xfrm>
          <a:prstGeom prst="rect">
            <a:avLst/>
          </a:prstGeom>
        </p:spPr>
        <p:txBody>
          <a:bodyPr vert="horz" lIns="96634" tIns="48317" rIns="96634" bIns="48317" rtlCol="0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519055"/>
            <a:ext cx="2985558" cy="502834"/>
          </a:xfrm>
          <a:prstGeom prst="rect">
            <a:avLst/>
          </a:prstGeom>
        </p:spPr>
        <p:txBody>
          <a:bodyPr vert="horz" lIns="96634" tIns="48317" rIns="96634" bIns="48317" rtlCol="0" anchor="b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902597" y="9519055"/>
            <a:ext cx="2985558" cy="502834"/>
          </a:xfrm>
          <a:prstGeom prst="rect">
            <a:avLst/>
          </a:prstGeom>
        </p:spPr>
        <p:txBody>
          <a:bodyPr vert="horz" lIns="96634" tIns="48317" rIns="96634" bIns="48317" rtlCol="0" anchor="b"/>
          <a:lstStyle>
            <a:lvl1pPr algn="r">
              <a:defRPr sz="1300"/>
            </a:lvl1pPr>
          </a:lstStyle>
          <a:p>
            <a:fld id="{D3554FBB-5347-4C5F-BB9D-09F70482850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920570996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  <p:notesStyle>
    <a:lvl1pPr marL="0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1pPr>
    <a:lvl2pPr marL="837965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2pPr>
    <a:lvl3pPr marL="1675930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3pPr>
    <a:lvl4pPr marL="2513895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4pPr>
    <a:lvl5pPr marL="3351860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5pPr>
    <a:lvl6pPr marL="4189826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6pPr>
    <a:lvl7pPr marL="5027791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7pPr>
    <a:lvl8pPr marL="5865756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8pPr>
    <a:lvl9pPr marL="6703721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72026" y="3593900"/>
            <a:ext cx="11016298" cy="7645294"/>
          </a:xfrm>
        </p:spPr>
        <p:txBody>
          <a:bodyPr anchor="b"/>
          <a:lstStyle>
            <a:lvl1pPr algn="ctr">
              <a:defRPr sz="8504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20045" y="11534026"/>
            <a:ext cx="9720263" cy="5301888"/>
          </a:xfrm>
        </p:spPr>
        <p:txBody>
          <a:bodyPr/>
          <a:lstStyle>
            <a:lvl1pPr marL="0" indent="0" algn="ctr">
              <a:buNone/>
              <a:defRPr sz="3402"/>
            </a:lvl1pPr>
            <a:lvl2pPr marL="648004" indent="0" algn="ctr">
              <a:buNone/>
              <a:defRPr sz="2835"/>
            </a:lvl2pPr>
            <a:lvl3pPr marL="1296008" indent="0" algn="ctr">
              <a:buNone/>
              <a:defRPr sz="2551"/>
            </a:lvl3pPr>
            <a:lvl4pPr marL="1944013" indent="0" algn="ctr">
              <a:buNone/>
              <a:defRPr sz="2268"/>
            </a:lvl4pPr>
            <a:lvl5pPr marL="2592017" indent="0" algn="ctr">
              <a:buNone/>
              <a:defRPr sz="2268"/>
            </a:lvl5pPr>
            <a:lvl6pPr marL="3240020" indent="0" algn="ctr">
              <a:buNone/>
              <a:defRPr sz="2268"/>
            </a:lvl6pPr>
            <a:lvl7pPr marL="3888025" indent="0" algn="ctr">
              <a:buNone/>
              <a:defRPr sz="2268"/>
            </a:lvl7pPr>
            <a:lvl8pPr marL="4536030" indent="0" algn="ctr">
              <a:buNone/>
              <a:defRPr sz="2268"/>
            </a:lvl8pPr>
            <a:lvl9pPr marL="5184033" indent="0" algn="ctr">
              <a:buNone/>
              <a:defRPr sz="2268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33E5F-05D8-4883-BBA5-F544EA65A67D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09468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78F2E-E25A-4875-A211-19CDE50E7B66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8634589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274753" y="1169161"/>
            <a:ext cx="2794575" cy="18609990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91025" y="1169161"/>
            <a:ext cx="8221722" cy="18609990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23612-7092-43E6-87EE-5F3D47EAF4DF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7751473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0705D-CDE0-4A8B-BD00-0C51EB3C5965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7144320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4275" y="5474729"/>
            <a:ext cx="11178302" cy="9134702"/>
          </a:xfrm>
        </p:spPr>
        <p:txBody>
          <a:bodyPr anchor="b"/>
          <a:lstStyle>
            <a:lvl1pPr>
              <a:defRPr sz="8504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4275" y="14695848"/>
            <a:ext cx="11178302" cy="4803724"/>
          </a:xfrm>
        </p:spPr>
        <p:txBody>
          <a:bodyPr/>
          <a:lstStyle>
            <a:lvl1pPr marL="0" indent="0">
              <a:buNone/>
              <a:defRPr sz="3402">
                <a:solidFill>
                  <a:schemeClr val="tx1"/>
                </a:solidFill>
              </a:defRPr>
            </a:lvl1pPr>
            <a:lvl2pPr marL="648004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2pPr>
            <a:lvl3pPr marL="1296008" indent="0">
              <a:buNone/>
              <a:defRPr sz="2551">
                <a:solidFill>
                  <a:schemeClr val="tx1">
                    <a:tint val="75000"/>
                  </a:schemeClr>
                </a:solidFill>
              </a:defRPr>
            </a:lvl3pPr>
            <a:lvl4pPr marL="1944013" indent="0">
              <a:buNone/>
              <a:defRPr sz="2268">
                <a:solidFill>
                  <a:schemeClr val="tx1">
                    <a:tint val="75000"/>
                  </a:schemeClr>
                </a:solidFill>
              </a:defRPr>
            </a:lvl4pPr>
            <a:lvl5pPr marL="2592017" indent="0">
              <a:buNone/>
              <a:defRPr sz="2268">
                <a:solidFill>
                  <a:schemeClr val="tx1">
                    <a:tint val="75000"/>
                  </a:schemeClr>
                </a:solidFill>
              </a:defRPr>
            </a:lvl5pPr>
            <a:lvl6pPr marL="3240020" indent="0">
              <a:buNone/>
              <a:defRPr sz="2268">
                <a:solidFill>
                  <a:schemeClr val="tx1">
                    <a:tint val="75000"/>
                  </a:schemeClr>
                </a:solidFill>
              </a:defRPr>
            </a:lvl6pPr>
            <a:lvl7pPr marL="3888025" indent="0">
              <a:buNone/>
              <a:defRPr sz="2268">
                <a:solidFill>
                  <a:schemeClr val="tx1">
                    <a:tint val="75000"/>
                  </a:schemeClr>
                </a:solidFill>
              </a:defRPr>
            </a:lvl7pPr>
            <a:lvl8pPr marL="4536030" indent="0">
              <a:buNone/>
              <a:defRPr sz="2268">
                <a:solidFill>
                  <a:schemeClr val="tx1">
                    <a:tint val="75000"/>
                  </a:schemeClr>
                </a:solidFill>
              </a:defRPr>
            </a:lvl8pPr>
            <a:lvl9pPr marL="5184033" indent="0">
              <a:buNone/>
              <a:defRPr sz="226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4F3DD-5303-44B3-94EB-3881814DB7A2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41112720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91024" y="5845805"/>
            <a:ext cx="5508149" cy="13933347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561179" y="5845805"/>
            <a:ext cx="5508149" cy="13933347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F68C83-F889-49C6-8258-A889429BD78F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4724813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92712" y="1169166"/>
            <a:ext cx="11178302" cy="4244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92715" y="5383224"/>
            <a:ext cx="5482835" cy="2638235"/>
          </a:xfrm>
        </p:spPr>
        <p:txBody>
          <a:bodyPr anchor="b"/>
          <a:lstStyle>
            <a:lvl1pPr marL="0" indent="0">
              <a:buNone/>
              <a:defRPr sz="3402" b="1"/>
            </a:lvl1pPr>
            <a:lvl2pPr marL="648004" indent="0">
              <a:buNone/>
              <a:defRPr sz="2835" b="1"/>
            </a:lvl2pPr>
            <a:lvl3pPr marL="1296008" indent="0">
              <a:buNone/>
              <a:defRPr sz="2551" b="1"/>
            </a:lvl3pPr>
            <a:lvl4pPr marL="1944013" indent="0">
              <a:buNone/>
              <a:defRPr sz="2268" b="1"/>
            </a:lvl4pPr>
            <a:lvl5pPr marL="2592017" indent="0">
              <a:buNone/>
              <a:defRPr sz="2268" b="1"/>
            </a:lvl5pPr>
            <a:lvl6pPr marL="3240020" indent="0">
              <a:buNone/>
              <a:defRPr sz="2268" b="1"/>
            </a:lvl6pPr>
            <a:lvl7pPr marL="3888025" indent="0">
              <a:buNone/>
              <a:defRPr sz="2268" b="1"/>
            </a:lvl7pPr>
            <a:lvl8pPr marL="4536030" indent="0">
              <a:buNone/>
              <a:defRPr sz="2268" b="1"/>
            </a:lvl8pPr>
            <a:lvl9pPr marL="5184033" indent="0">
              <a:buNone/>
              <a:defRPr sz="2268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92715" y="8021460"/>
            <a:ext cx="5482835" cy="1179835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561180" y="5383224"/>
            <a:ext cx="5509837" cy="2638235"/>
          </a:xfrm>
        </p:spPr>
        <p:txBody>
          <a:bodyPr anchor="b"/>
          <a:lstStyle>
            <a:lvl1pPr marL="0" indent="0">
              <a:buNone/>
              <a:defRPr sz="3402" b="1"/>
            </a:lvl1pPr>
            <a:lvl2pPr marL="648004" indent="0">
              <a:buNone/>
              <a:defRPr sz="2835" b="1"/>
            </a:lvl2pPr>
            <a:lvl3pPr marL="1296008" indent="0">
              <a:buNone/>
              <a:defRPr sz="2551" b="1"/>
            </a:lvl3pPr>
            <a:lvl4pPr marL="1944013" indent="0">
              <a:buNone/>
              <a:defRPr sz="2268" b="1"/>
            </a:lvl4pPr>
            <a:lvl5pPr marL="2592017" indent="0">
              <a:buNone/>
              <a:defRPr sz="2268" b="1"/>
            </a:lvl5pPr>
            <a:lvl6pPr marL="3240020" indent="0">
              <a:buNone/>
              <a:defRPr sz="2268" b="1"/>
            </a:lvl6pPr>
            <a:lvl7pPr marL="3888025" indent="0">
              <a:buNone/>
              <a:defRPr sz="2268" b="1"/>
            </a:lvl7pPr>
            <a:lvl8pPr marL="4536030" indent="0">
              <a:buNone/>
              <a:defRPr sz="2268" b="1"/>
            </a:lvl8pPr>
            <a:lvl9pPr marL="5184033" indent="0">
              <a:buNone/>
              <a:defRPr sz="2268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561180" y="8021460"/>
            <a:ext cx="5509837" cy="1179835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F85AAA-86E6-4820-B832-9D5BB2BD7504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2441098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D3C208-5E4C-41D1-9C78-730AEC10AC88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42151795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B92E73-36E3-4BA5-A847-F77E213AA44F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5142106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92712" y="1463993"/>
            <a:ext cx="4180050" cy="5123974"/>
          </a:xfrm>
        </p:spPr>
        <p:txBody>
          <a:bodyPr anchor="b"/>
          <a:lstStyle>
            <a:lvl1pPr>
              <a:defRPr sz="4536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509839" y="3161822"/>
            <a:ext cx="6561177" cy="15605754"/>
          </a:xfrm>
        </p:spPr>
        <p:txBody>
          <a:bodyPr/>
          <a:lstStyle>
            <a:lvl1pPr>
              <a:defRPr sz="4536"/>
            </a:lvl1pPr>
            <a:lvl2pPr>
              <a:defRPr sz="3968"/>
            </a:lvl2pPr>
            <a:lvl3pPr>
              <a:defRPr sz="3402"/>
            </a:lvl3pPr>
            <a:lvl4pPr>
              <a:defRPr sz="2835"/>
            </a:lvl4pPr>
            <a:lvl5pPr>
              <a:defRPr sz="2835"/>
            </a:lvl5pPr>
            <a:lvl6pPr>
              <a:defRPr sz="2835"/>
            </a:lvl6pPr>
            <a:lvl7pPr>
              <a:defRPr sz="2835"/>
            </a:lvl7pPr>
            <a:lvl8pPr>
              <a:defRPr sz="2835"/>
            </a:lvl8pPr>
            <a:lvl9pPr>
              <a:defRPr sz="2835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92712" y="6587967"/>
            <a:ext cx="4180050" cy="12205023"/>
          </a:xfrm>
        </p:spPr>
        <p:txBody>
          <a:bodyPr/>
          <a:lstStyle>
            <a:lvl1pPr marL="0" indent="0">
              <a:buNone/>
              <a:defRPr sz="2268"/>
            </a:lvl1pPr>
            <a:lvl2pPr marL="648004" indent="0">
              <a:buNone/>
              <a:defRPr sz="1984"/>
            </a:lvl2pPr>
            <a:lvl3pPr marL="1296008" indent="0">
              <a:buNone/>
              <a:defRPr sz="1701"/>
            </a:lvl3pPr>
            <a:lvl4pPr marL="1944013" indent="0">
              <a:buNone/>
              <a:defRPr sz="1418"/>
            </a:lvl4pPr>
            <a:lvl5pPr marL="2592017" indent="0">
              <a:buNone/>
              <a:defRPr sz="1418"/>
            </a:lvl5pPr>
            <a:lvl6pPr marL="3240020" indent="0">
              <a:buNone/>
              <a:defRPr sz="1418"/>
            </a:lvl6pPr>
            <a:lvl7pPr marL="3888025" indent="0">
              <a:buNone/>
              <a:defRPr sz="1418"/>
            </a:lvl7pPr>
            <a:lvl8pPr marL="4536030" indent="0">
              <a:buNone/>
              <a:defRPr sz="1418"/>
            </a:lvl8pPr>
            <a:lvl9pPr marL="5184033" indent="0">
              <a:buNone/>
              <a:defRPr sz="1418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7ED3DE-4B30-48B5-95BB-DF6A3298C28C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910707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92712" y="1463993"/>
            <a:ext cx="4180050" cy="5123974"/>
          </a:xfrm>
        </p:spPr>
        <p:txBody>
          <a:bodyPr anchor="b"/>
          <a:lstStyle>
            <a:lvl1pPr>
              <a:defRPr sz="4536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509839" y="3161822"/>
            <a:ext cx="6561177" cy="15605754"/>
          </a:xfrm>
        </p:spPr>
        <p:txBody>
          <a:bodyPr anchor="t"/>
          <a:lstStyle>
            <a:lvl1pPr marL="0" indent="0">
              <a:buNone/>
              <a:defRPr sz="4536"/>
            </a:lvl1pPr>
            <a:lvl2pPr marL="648004" indent="0">
              <a:buNone/>
              <a:defRPr sz="3968"/>
            </a:lvl2pPr>
            <a:lvl3pPr marL="1296008" indent="0">
              <a:buNone/>
              <a:defRPr sz="3402"/>
            </a:lvl3pPr>
            <a:lvl4pPr marL="1944013" indent="0">
              <a:buNone/>
              <a:defRPr sz="2835"/>
            </a:lvl4pPr>
            <a:lvl5pPr marL="2592017" indent="0">
              <a:buNone/>
              <a:defRPr sz="2835"/>
            </a:lvl5pPr>
            <a:lvl6pPr marL="3240020" indent="0">
              <a:buNone/>
              <a:defRPr sz="2835"/>
            </a:lvl6pPr>
            <a:lvl7pPr marL="3888025" indent="0">
              <a:buNone/>
              <a:defRPr sz="2835"/>
            </a:lvl7pPr>
            <a:lvl8pPr marL="4536030" indent="0">
              <a:buNone/>
              <a:defRPr sz="2835"/>
            </a:lvl8pPr>
            <a:lvl9pPr marL="5184033" indent="0">
              <a:buNone/>
              <a:defRPr sz="2835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92712" y="6587967"/>
            <a:ext cx="4180050" cy="12205023"/>
          </a:xfrm>
        </p:spPr>
        <p:txBody>
          <a:bodyPr/>
          <a:lstStyle>
            <a:lvl1pPr marL="0" indent="0">
              <a:buNone/>
              <a:defRPr sz="2268"/>
            </a:lvl1pPr>
            <a:lvl2pPr marL="648004" indent="0">
              <a:buNone/>
              <a:defRPr sz="1984"/>
            </a:lvl2pPr>
            <a:lvl3pPr marL="1296008" indent="0">
              <a:buNone/>
              <a:defRPr sz="1701"/>
            </a:lvl3pPr>
            <a:lvl4pPr marL="1944013" indent="0">
              <a:buNone/>
              <a:defRPr sz="1418"/>
            </a:lvl4pPr>
            <a:lvl5pPr marL="2592017" indent="0">
              <a:buNone/>
              <a:defRPr sz="1418"/>
            </a:lvl5pPr>
            <a:lvl6pPr marL="3240020" indent="0">
              <a:buNone/>
              <a:defRPr sz="1418"/>
            </a:lvl6pPr>
            <a:lvl7pPr marL="3888025" indent="0">
              <a:buNone/>
              <a:defRPr sz="1418"/>
            </a:lvl7pPr>
            <a:lvl8pPr marL="4536030" indent="0">
              <a:buNone/>
              <a:defRPr sz="1418"/>
            </a:lvl8pPr>
            <a:lvl9pPr marL="5184033" indent="0">
              <a:buNone/>
              <a:defRPr sz="1418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6E1A72-34A7-4777-9297-BECAC6DDF237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9121506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91024" y="1169166"/>
            <a:ext cx="11178302" cy="4244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91024" y="5845805"/>
            <a:ext cx="11178302" cy="1393334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91026" y="20353569"/>
            <a:ext cx="2916079" cy="11691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0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3E6F1D-3C5F-40DC-B246-DD4AB1E6FA63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293116" y="20353569"/>
            <a:ext cx="4374118" cy="11691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0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153249" y="20353569"/>
            <a:ext cx="2916079" cy="11691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0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1109336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hf sldNum="0" hdr="0" ftr="0" dt="0"/>
  <p:txStyles>
    <p:titleStyle>
      <a:lvl1pPr algn="l" defTabSz="1296008" rtl="0" eaLnBrk="1" latinLnBrk="1" hangingPunct="1">
        <a:lnSpc>
          <a:spcPct val="90000"/>
        </a:lnSpc>
        <a:spcBef>
          <a:spcPct val="0"/>
        </a:spcBef>
        <a:buNone/>
        <a:defRPr sz="623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24003" indent="-324003" algn="l" defTabSz="1296008" rtl="0" eaLnBrk="1" latinLnBrk="1" hangingPunct="1">
        <a:lnSpc>
          <a:spcPct val="90000"/>
        </a:lnSpc>
        <a:spcBef>
          <a:spcPts val="1418"/>
        </a:spcBef>
        <a:buFont typeface="Arial" panose="020B0604020202020204" pitchFamily="34" charset="0"/>
        <a:buChar char="•"/>
        <a:defRPr sz="3968" kern="1200">
          <a:solidFill>
            <a:schemeClr val="tx1"/>
          </a:solidFill>
          <a:latin typeface="+mn-lt"/>
          <a:ea typeface="+mn-ea"/>
          <a:cs typeface="+mn-cs"/>
        </a:defRPr>
      </a:lvl1pPr>
      <a:lvl2pPr marL="972007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3402" kern="1200">
          <a:solidFill>
            <a:schemeClr val="tx1"/>
          </a:solidFill>
          <a:latin typeface="+mn-lt"/>
          <a:ea typeface="+mn-ea"/>
          <a:cs typeface="+mn-cs"/>
        </a:defRPr>
      </a:lvl2pPr>
      <a:lvl3pPr marL="1620010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3pPr>
      <a:lvl4pPr marL="2268014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551" kern="1200">
          <a:solidFill>
            <a:schemeClr val="tx1"/>
          </a:solidFill>
          <a:latin typeface="+mn-lt"/>
          <a:ea typeface="+mn-ea"/>
          <a:cs typeface="+mn-cs"/>
        </a:defRPr>
      </a:lvl4pPr>
      <a:lvl5pPr marL="2916020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551" kern="1200">
          <a:solidFill>
            <a:schemeClr val="tx1"/>
          </a:solidFill>
          <a:latin typeface="+mn-lt"/>
          <a:ea typeface="+mn-ea"/>
          <a:cs typeface="+mn-cs"/>
        </a:defRPr>
      </a:lvl5pPr>
      <a:lvl6pPr marL="3564023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551" kern="1200">
          <a:solidFill>
            <a:schemeClr val="tx1"/>
          </a:solidFill>
          <a:latin typeface="+mn-lt"/>
          <a:ea typeface="+mn-ea"/>
          <a:cs typeface="+mn-cs"/>
        </a:defRPr>
      </a:lvl6pPr>
      <a:lvl7pPr marL="4212027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551" kern="1200">
          <a:solidFill>
            <a:schemeClr val="tx1"/>
          </a:solidFill>
          <a:latin typeface="+mn-lt"/>
          <a:ea typeface="+mn-ea"/>
          <a:cs typeface="+mn-cs"/>
        </a:defRPr>
      </a:lvl7pPr>
      <a:lvl8pPr marL="4860032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551" kern="1200">
          <a:solidFill>
            <a:schemeClr val="tx1"/>
          </a:solidFill>
          <a:latin typeface="+mn-lt"/>
          <a:ea typeface="+mn-ea"/>
          <a:cs typeface="+mn-cs"/>
        </a:defRPr>
      </a:lvl8pPr>
      <a:lvl9pPr marL="5508036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5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1pPr>
      <a:lvl2pPr marL="648004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2pPr>
      <a:lvl3pPr marL="1296008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3pPr>
      <a:lvl4pPr marL="1944013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4pPr>
      <a:lvl5pPr marL="2592017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5pPr>
      <a:lvl6pPr marL="3240020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6pPr>
      <a:lvl7pPr marL="3888025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7pPr>
      <a:lvl8pPr marL="4536030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8pPr>
      <a:lvl9pPr marL="5184033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표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1905954236"/>
              </p:ext>
            </p:extLst>
          </p:nvPr>
        </p:nvGraphicFramePr>
        <p:xfrm>
          <a:off x="82238" y="6745441"/>
          <a:ext cx="12834550" cy="321754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074638">
                  <a:extLst>
                    <a:ext uri="{9D8B030D-6E8A-4147-A177-3AD203B41FA5}">
                      <a16:colId xmlns:a16="http://schemas.microsoft.com/office/drawing/2014/main" xmlns="" val="1409189042"/>
                    </a:ext>
                  </a:extLst>
                </a:gridCol>
                <a:gridCol w="128016">
                  <a:extLst>
                    <a:ext uri="{9D8B030D-6E8A-4147-A177-3AD203B41FA5}">
                      <a16:colId xmlns:a16="http://schemas.microsoft.com/office/drawing/2014/main" xmlns="" val="2094567051"/>
                    </a:ext>
                  </a:extLst>
                </a:gridCol>
                <a:gridCol w="1097280">
                  <a:extLst>
                    <a:ext uri="{9D8B030D-6E8A-4147-A177-3AD203B41FA5}">
                      <a16:colId xmlns:a16="http://schemas.microsoft.com/office/drawing/2014/main" xmlns="" val="3571531918"/>
                    </a:ext>
                  </a:extLst>
                </a:gridCol>
                <a:gridCol w="1170432">
                  <a:extLst>
                    <a:ext uri="{9D8B030D-6E8A-4147-A177-3AD203B41FA5}">
                      <a16:colId xmlns:a16="http://schemas.microsoft.com/office/drawing/2014/main" xmlns="" val="4088979873"/>
                    </a:ext>
                  </a:extLst>
                </a:gridCol>
                <a:gridCol w="4685578">
                  <a:extLst>
                    <a:ext uri="{9D8B030D-6E8A-4147-A177-3AD203B41FA5}">
                      <a16:colId xmlns:a16="http://schemas.microsoft.com/office/drawing/2014/main" xmlns="" val="120783647"/>
                    </a:ext>
                  </a:extLst>
                </a:gridCol>
                <a:gridCol w="895350">
                  <a:extLst>
                    <a:ext uri="{9D8B030D-6E8A-4147-A177-3AD203B41FA5}">
                      <a16:colId xmlns:a16="http://schemas.microsoft.com/office/drawing/2014/main" xmlns="" val="3270725404"/>
                    </a:ext>
                  </a:extLst>
                </a:gridCol>
                <a:gridCol w="1162050">
                  <a:extLst>
                    <a:ext uri="{9D8B030D-6E8A-4147-A177-3AD203B41FA5}">
                      <a16:colId xmlns:a16="http://schemas.microsoft.com/office/drawing/2014/main" xmlns="" val="3683565691"/>
                    </a:ext>
                  </a:extLst>
                </a:gridCol>
                <a:gridCol w="800100">
                  <a:extLst>
                    <a:ext uri="{9D8B030D-6E8A-4147-A177-3AD203B41FA5}">
                      <a16:colId xmlns:a16="http://schemas.microsoft.com/office/drawing/2014/main" xmlns="" val="3525253308"/>
                    </a:ext>
                  </a:extLst>
                </a:gridCol>
                <a:gridCol w="821106">
                  <a:extLst>
                    <a:ext uri="{9D8B030D-6E8A-4147-A177-3AD203B41FA5}">
                      <a16:colId xmlns:a16="http://schemas.microsoft.com/office/drawing/2014/main" xmlns="" val="2749235395"/>
                    </a:ext>
                  </a:extLst>
                </a:gridCol>
              </a:tblGrid>
              <a:tr h="404646">
                <a:tc rowSpan="2" gridSpan="2">
                  <a:txBody>
                    <a:bodyPr/>
                    <a:lstStyle/>
                    <a:p>
                      <a:pPr algn="l" latinLnBrk="1">
                        <a:lnSpc>
                          <a:spcPct val="80000"/>
                        </a:lnSpc>
                      </a:pPr>
                      <a:r>
                        <a:rPr lang="en-US" altLang="ko-KR" sz="20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.       </a:t>
                      </a: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udy 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FS/ME</a:t>
                      </a:r>
                      <a:r>
                        <a:rPr lang="en-US" altLang="ko-KR" sz="1500" baseline="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ases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ses of</a:t>
                      </a:r>
                      <a:r>
                        <a:rPr lang="en-US" altLang="ko-KR" sz="1500" baseline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ustralian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cidence Rate (%)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te (%) 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%-CI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ight %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506282246"/>
                  </a:ext>
                </a:extLst>
              </a:tr>
              <a:tr h="404646">
                <a:tc gridSpan="2"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xed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ndom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65054661"/>
                  </a:ext>
                </a:extLst>
              </a:tr>
              <a:tr h="301176">
                <a:tc gridSpan="2">
                  <a:txBody>
                    <a:bodyPr/>
                    <a:lstStyle/>
                    <a:p>
                      <a:pPr marL="0" marR="0" lvl="0" indent="0" algn="l" defTabSz="1320759" rtl="0" eaLnBrk="1" fontAlgn="ctr" latinLnBrk="1" hangingPunct="1">
                        <a:lnSpc>
                          <a:spcPct val="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ko-KR" sz="15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l" defTabSz="1320759" rtl="0" eaLnBrk="1" fontAlgn="ctr" latinLnBrk="1" hangingPunct="1">
                        <a:lnSpc>
                          <a:spcPct val="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ko-KR" sz="15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l" defTabSz="1320759" rtl="0" eaLnBrk="1" fontAlgn="ctr" latinLnBrk="1" hangingPunct="1">
                        <a:lnSpc>
                          <a:spcPct val="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ko-KR" sz="15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l" defTabSz="1320759" rtl="0" eaLnBrk="1" fontAlgn="ctr" latinLnBrk="1" hangingPunct="1">
                        <a:lnSpc>
                          <a:spcPct val="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ko-KR" sz="15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l" defTabSz="1320759" rtl="0" eaLnBrk="1" fontAlgn="ctr" latinLnBrk="1" hangingPunct="1">
                        <a:lnSpc>
                          <a:spcPct val="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Lindal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2002 [34]</a:t>
                      </a: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l" fontAlgn="ctr">
                        <a:lnSpc>
                          <a:spcPct val="20000"/>
                        </a:lnSpc>
                      </a:pP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2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20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8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.6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6.61; 8.78]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.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102593090"/>
                  </a:ext>
                </a:extLst>
              </a:tr>
              <a:tr h="301176">
                <a:tc gridSpan="2">
                  <a:txBody>
                    <a:bodyPr/>
                    <a:lstStyle/>
                    <a:p>
                      <a:pPr marL="0" marR="0" lvl="0" indent="0" algn="l" defTabSz="1320759" rtl="0" eaLnBrk="1" fontAlgn="ctr" latinLnBrk="1" hangingPunct="1">
                        <a:lnSpc>
                          <a:spcPct val="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ko-KR" sz="15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l" defTabSz="1320759" rtl="0" eaLnBrk="1" fontAlgn="ctr" latinLnBrk="1" hangingPunct="1">
                        <a:lnSpc>
                          <a:spcPct val="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ko-KR" sz="15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l" defTabSz="1320759" rtl="0" eaLnBrk="1" fontAlgn="ctr" latinLnBrk="1" hangingPunct="1">
                        <a:lnSpc>
                          <a:spcPct val="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ko-KR" sz="15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l" defTabSz="1320759" rtl="0" eaLnBrk="1" fontAlgn="ctr" latinLnBrk="1" hangingPunct="1">
                        <a:lnSpc>
                          <a:spcPct val="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ko-KR" sz="15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l" defTabSz="1320759" rtl="0" eaLnBrk="1" fontAlgn="ctr" latinLnBrk="1" hangingPunct="1">
                        <a:lnSpc>
                          <a:spcPct val="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essely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1997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[16]       </a:t>
                      </a: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l" fontAlgn="ctr">
                        <a:lnSpc>
                          <a:spcPct val="20000"/>
                        </a:lnSpc>
                      </a:pP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85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4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97; 2.04]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6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898440909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marL="0" marR="0" lvl="0" indent="0" algn="l" defTabSz="1320759" rtl="0" eaLnBrk="1" fontAlgn="ctr" latinLnBrk="1" hangingPunct="1">
                        <a:lnSpc>
                          <a:spcPct val="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ko-KR" sz="15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l" defTabSz="1320759" rtl="0" eaLnBrk="1" fontAlgn="ctr" latinLnBrk="1" hangingPunct="1">
                        <a:lnSpc>
                          <a:spcPct val="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ko-KR" sz="15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l" defTabSz="1320759" rtl="0" eaLnBrk="1" fontAlgn="ctr" latinLnBrk="1" hangingPunct="1">
                        <a:lnSpc>
                          <a:spcPct val="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ko-KR" sz="15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l" defTabSz="1320759" rtl="0" eaLnBrk="1" fontAlgn="ctr" latinLnBrk="1" hangingPunct="1">
                        <a:lnSpc>
                          <a:spcPct val="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ates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1993 [39]</a:t>
                      </a: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l" fontAlgn="ctr">
                        <a:lnSpc>
                          <a:spcPct val="20000"/>
                        </a:lnSpc>
                      </a:pP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95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54;1.87]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180887130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marL="0" marR="0" lvl="0" indent="0" algn="l" defTabSz="1320759" rtl="0" eaLnBrk="1" fontAlgn="ctr" latinLnBrk="1" hangingPunct="1">
                        <a:lnSpc>
                          <a:spcPct val="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ko-KR" sz="15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l" defTabSz="1320759" rtl="0" eaLnBrk="1" fontAlgn="ctr" latinLnBrk="1" hangingPunct="1">
                        <a:lnSpc>
                          <a:spcPct val="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ko-KR" sz="15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l" defTabSz="1320759" rtl="0" eaLnBrk="1" fontAlgn="ctr" latinLnBrk="1" hangingPunct="1">
                        <a:lnSpc>
                          <a:spcPct val="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ko-KR" sz="15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l" defTabSz="1320759" rtl="0" eaLnBrk="1" fontAlgn="ctr" latinLnBrk="1" hangingPunct="1">
                        <a:lnSpc>
                          <a:spcPct val="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ko-KR" sz="15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l" defTabSz="1320759" rtl="0" eaLnBrk="1" fontAlgn="ctr" latinLnBrk="1" hangingPunct="1">
                        <a:lnSpc>
                          <a:spcPct val="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Lloyd 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990 [25]</a:t>
                      </a: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l" fontAlgn="ctr">
                        <a:lnSpc>
                          <a:spcPct val="20000"/>
                        </a:lnSpc>
                      </a:pP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4000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03; 0.05]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029290213"/>
                  </a:ext>
                </a:extLst>
              </a:tr>
              <a:tr h="377963">
                <a:tc rowSpan="2" gridSpan="2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en-US" altLang="ko-KR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r>
                        <a:rPr lang="en-US" altLang="ko-KR" sz="15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US" altLang="ko-KR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r>
                        <a:rPr lang="en-US" altLang="ko-KR" sz="15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xed effect model </a:t>
                      </a:r>
                      <a:endParaRPr lang="ko-KR" altLang="en-US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latinLnBrk="1"/>
                      <a:endParaRPr lang="ko-KR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61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2.32; 2.94]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.0%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-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114836199"/>
                  </a:ext>
                </a:extLst>
              </a:tr>
              <a:tr h="0">
                <a:tc gridSpan="2"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9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0.05; 12.55]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-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.0%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097430175"/>
                  </a:ext>
                </a:extLst>
              </a:tr>
              <a:tr h="298246">
                <a:tc gridSpan="3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en-US" altLang="ko-KR" sz="15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r>
                        <a:rPr lang="en-US" altLang="ko-KR" sz="15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ndom</a:t>
                      </a:r>
                      <a:r>
                        <a:rPr lang="en-US" altLang="ko-KR" sz="1500" b="1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b="1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ffects model</a:t>
                      </a:r>
                      <a:endParaRPr lang="ko-KR" altLang="en-US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sz="10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3901064984"/>
                  </a:ext>
                </a:extLst>
              </a:tr>
              <a:tr h="296563"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r>
                        <a:rPr lang="en-US" altLang="ko-KR" sz="15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terogeneity </a:t>
                      </a:r>
                      <a:endParaRPr lang="ko-KR" altLang="en-US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1320759" rtl="0" eaLnBrk="1" fontAlgn="auto" latinLnBrk="1" hangingPunct="1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500" i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</a:t>
                      </a:r>
                      <a:r>
                        <a:rPr lang="en-US" altLang="ko-KR" sz="1500" i="1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I</a:t>
                      </a:r>
                      <a:r>
                        <a:rPr lang="en-US" altLang="ko-KR" sz="1500" baseline="300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 99.7%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l" defTabSz="1320759" rtl="0" eaLnBrk="1" fontAlgn="auto" latinLnBrk="1" hangingPunct="1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latinLnBrk="1">
                        <a:lnSpc>
                          <a:spcPct val="80000"/>
                        </a:lnSpc>
                      </a:pPr>
                      <a:r>
                        <a:rPr lang="en-US" altLang="ko-KR" sz="1500" i="1" baseline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i="1" baseline="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</a:t>
                      </a:r>
                      <a:r>
                        <a:rPr lang="en-US" altLang="ko-KR" sz="1500" i="1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</a:t>
                      </a:r>
                      <a:r>
                        <a:rPr lang="en-US" altLang="ko-KR" sz="1500" baseline="300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 7.8860</a:t>
                      </a:r>
                    </a:p>
                    <a:p>
                      <a:pPr marL="0" marR="0" lvl="0" indent="0" algn="l" defTabSz="1320759" rtl="0" eaLnBrk="1" fontAlgn="auto" latinLnBrk="1" hangingPunct="1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500" i="1" baseline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P</a:t>
                      </a: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&lt;0.01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sz="800" dirty="0"/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sz="800" dirty="0"/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sz="800" dirty="0"/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440330890"/>
                  </a:ext>
                </a:extLst>
              </a:tr>
            </a:tbl>
          </a:graphicData>
        </a:graphic>
      </p:graphicFrame>
      <p:graphicFrame>
        <p:nvGraphicFramePr>
          <p:cNvPr id="10" name="표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2468737650"/>
              </p:ext>
            </p:extLst>
          </p:nvPr>
        </p:nvGraphicFramePr>
        <p:xfrm>
          <a:off x="72777" y="1850140"/>
          <a:ext cx="12834550" cy="4541101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193827">
                  <a:extLst>
                    <a:ext uri="{9D8B030D-6E8A-4147-A177-3AD203B41FA5}">
                      <a16:colId xmlns:a16="http://schemas.microsoft.com/office/drawing/2014/main" xmlns="" val="1409189042"/>
                    </a:ext>
                  </a:extLst>
                </a:gridCol>
                <a:gridCol w="420624">
                  <a:extLst>
                    <a:ext uri="{9D8B030D-6E8A-4147-A177-3AD203B41FA5}">
                      <a16:colId xmlns:a16="http://schemas.microsoft.com/office/drawing/2014/main" xmlns="" val="2039758758"/>
                    </a:ext>
                  </a:extLst>
                </a:gridCol>
                <a:gridCol w="859536">
                  <a:extLst>
                    <a:ext uri="{9D8B030D-6E8A-4147-A177-3AD203B41FA5}">
                      <a16:colId xmlns:a16="http://schemas.microsoft.com/office/drawing/2014/main" xmlns="" val="3571531918"/>
                    </a:ext>
                  </a:extLst>
                </a:gridCol>
                <a:gridCol w="1060704">
                  <a:extLst>
                    <a:ext uri="{9D8B030D-6E8A-4147-A177-3AD203B41FA5}">
                      <a16:colId xmlns:a16="http://schemas.microsoft.com/office/drawing/2014/main" xmlns="" val="4088979873"/>
                    </a:ext>
                  </a:extLst>
                </a:gridCol>
                <a:gridCol w="4635246">
                  <a:extLst>
                    <a:ext uri="{9D8B030D-6E8A-4147-A177-3AD203B41FA5}">
                      <a16:colId xmlns:a16="http://schemas.microsoft.com/office/drawing/2014/main" xmlns="" val="120783647"/>
                    </a:ext>
                  </a:extLst>
                </a:gridCol>
                <a:gridCol w="857250">
                  <a:extLst>
                    <a:ext uri="{9D8B030D-6E8A-4147-A177-3AD203B41FA5}">
                      <a16:colId xmlns:a16="http://schemas.microsoft.com/office/drawing/2014/main" xmlns="" val="3270725404"/>
                    </a:ext>
                  </a:extLst>
                </a:gridCol>
                <a:gridCol w="1162050">
                  <a:extLst>
                    <a:ext uri="{9D8B030D-6E8A-4147-A177-3AD203B41FA5}">
                      <a16:colId xmlns:a16="http://schemas.microsoft.com/office/drawing/2014/main" xmlns="" val="3683565691"/>
                    </a:ext>
                  </a:extLst>
                </a:gridCol>
                <a:gridCol w="781050">
                  <a:extLst>
                    <a:ext uri="{9D8B030D-6E8A-4147-A177-3AD203B41FA5}">
                      <a16:colId xmlns:a16="http://schemas.microsoft.com/office/drawing/2014/main" xmlns="" val="3525253308"/>
                    </a:ext>
                  </a:extLst>
                </a:gridCol>
                <a:gridCol w="864263">
                  <a:extLst>
                    <a:ext uri="{9D8B030D-6E8A-4147-A177-3AD203B41FA5}">
                      <a16:colId xmlns:a16="http://schemas.microsoft.com/office/drawing/2014/main" xmlns="" val="2749235395"/>
                    </a:ext>
                  </a:extLst>
                </a:gridCol>
              </a:tblGrid>
              <a:tr h="404646">
                <a:tc rowSpan="2" gridSpan="2">
                  <a:txBody>
                    <a:bodyPr/>
                    <a:lstStyle/>
                    <a:p>
                      <a:pPr algn="l" latinLnBrk="1">
                        <a:lnSpc>
                          <a:spcPct val="80000"/>
                        </a:lnSpc>
                      </a:pPr>
                      <a:r>
                        <a:rPr lang="en-US" altLang="ko-KR" sz="20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.       </a:t>
                      </a: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udy 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400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FS/ME</a:t>
                      </a:r>
                      <a:r>
                        <a:rPr lang="en-US" altLang="ko-KR" sz="1500" baseline="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ases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ses of</a:t>
                      </a:r>
                      <a:r>
                        <a:rPr lang="en-US" altLang="ko-KR" sz="1500" baseline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Holmes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cidence Rate (%)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te (%) 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%-CI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ight %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506282246"/>
                  </a:ext>
                </a:extLst>
              </a:tr>
              <a:tr h="404646">
                <a:tc gridSpan="2"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xed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ndom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65054661"/>
                  </a:ext>
                </a:extLst>
              </a:tr>
              <a:tr h="301176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Lindal</a:t>
                      </a:r>
                      <a:r>
                        <a:rPr lang="en-US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2 [34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20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10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00; 0.32]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102593090"/>
                  </a:ext>
                </a:extLst>
              </a:tr>
              <a:tr h="301176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Wessely</a:t>
                      </a:r>
                      <a:r>
                        <a:rPr lang="en-US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7 [16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85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2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81;</a:t>
                      </a:r>
                      <a:r>
                        <a:rPr lang="en-US" altLang="ko-KR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80]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898440909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Verslusis</a:t>
                      </a:r>
                      <a:r>
                        <a:rPr lang="en-US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7 [89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000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07; 0.16]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180887130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Buchwald</a:t>
                      </a:r>
                      <a:r>
                        <a:rPr lang="en-US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nd Umali, 1995 [91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66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03; 0.30]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029290213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Jason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5 [92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1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2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05; 0.88] 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114836199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Jason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3 [93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74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75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41; 1.35]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8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189424664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Bates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3 [39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95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3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10; 0.93] 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596925213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rice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2 [33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538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00; 0.05]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6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921524469"/>
                  </a:ext>
                </a:extLst>
              </a:tr>
              <a:tr h="369205">
                <a:tc gridSpan="2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en-US" altLang="ko-KR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endParaRPr lang="en-US" altLang="ko-KR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endParaRPr lang="en-US" altLang="ko-KR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r>
                        <a:rPr lang="en-US" altLang="ko-KR" sz="15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</a:p>
                    <a:p>
                      <a:pPr latinLnBrk="1">
                        <a:lnSpc>
                          <a:spcPct val="20000"/>
                        </a:lnSpc>
                      </a:pPr>
                      <a:r>
                        <a:rPr lang="en-US" altLang="ko-KR" sz="15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xed effect model </a:t>
                      </a:r>
                      <a:endParaRPr lang="ko-KR" altLang="en-US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40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4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0.27; 0.43]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.0%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-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014201241"/>
                  </a:ext>
                </a:extLst>
              </a:tr>
              <a:tr h="313111">
                <a:tc gridSpan="3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endParaRPr lang="en-US" altLang="ko-KR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r>
                        <a:rPr lang="en-US" altLang="ko-KR" sz="15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ndom</a:t>
                      </a:r>
                      <a:r>
                        <a:rPr lang="en-US" altLang="ko-KR" sz="1500" b="1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effects model</a:t>
                      </a:r>
                      <a:endParaRPr lang="ko-KR" altLang="en-US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4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7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0.06; 0.49]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-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.0%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257745429"/>
                  </a:ext>
                </a:extLst>
              </a:tr>
              <a:tr h="556781"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r>
                        <a:rPr lang="en-US" altLang="ko-KR" sz="15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terogeneity </a:t>
                      </a:r>
                      <a:endParaRPr lang="ko-KR" altLang="en-US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4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latinLnBrk="1">
                        <a:lnSpc>
                          <a:spcPct val="80000"/>
                        </a:lnSpc>
                      </a:pPr>
                      <a:r>
                        <a:rPr lang="en-US" altLang="ko-KR" sz="1500" i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i="1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</a:t>
                      </a:r>
                      <a:r>
                        <a:rPr lang="en-US" altLang="ko-KR" sz="1500" i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en-US" altLang="ko-KR" sz="1500" baseline="300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= 93.1%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l" latinLnBrk="1">
                        <a:lnSpc>
                          <a:spcPct val="80000"/>
                        </a:lnSpc>
                      </a:pP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latinLnBrk="1">
                        <a:lnSpc>
                          <a:spcPct val="80000"/>
                        </a:lnSpc>
                      </a:pPr>
                      <a:r>
                        <a:rPr lang="en-US" altLang="ko-KR" sz="1500" i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i="1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</a:t>
                      </a:r>
                      <a:r>
                        <a:rPr lang="en-US" altLang="ko-KR" sz="1500" baseline="300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 1.8890</a:t>
                      </a:r>
                    </a:p>
                    <a:p>
                      <a:pPr marL="0" marR="0" lvl="0" indent="0" algn="l" defTabSz="1320759" rtl="0" eaLnBrk="1" fontAlgn="auto" latinLnBrk="1" hangingPunct="1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500" i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i="1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1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838004142"/>
                  </a:ext>
                </a:extLst>
              </a:tr>
            </a:tbl>
          </a:graphicData>
        </a:graphic>
      </p:graphicFrame>
      <p:sp>
        <p:nvSpPr>
          <p:cNvPr id="11" name="TextBox 10"/>
          <p:cNvSpPr txBox="1"/>
          <p:nvPr/>
        </p:nvSpPr>
        <p:spPr>
          <a:xfrm>
            <a:off x="21971" y="1438210"/>
            <a:ext cx="135035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atinLnBrk="1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5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ta-analysis of CFS/ME prevalence based on the Holmes (A), Australian (B), Oxford (C), and other (D)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finitions</a:t>
            </a:r>
            <a:endParaRPr lang="ko-KR" altLang="ko-K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2" name="표 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1623026858"/>
              </p:ext>
            </p:extLst>
          </p:nvPr>
        </p:nvGraphicFramePr>
        <p:xfrm>
          <a:off x="57717" y="10416862"/>
          <a:ext cx="12834550" cy="328441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853522">
                  <a:extLst>
                    <a:ext uri="{9D8B030D-6E8A-4147-A177-3AD203B41FA5}">
                      <a16:colId xmlns:a16="http://schemas.microsoft.com/office/drawing/2014/main" xmlns="" val="1409189042"/>
                    </a:ext>
                  </a:extLst>
                </a:gridCol>
                <a:gridCol w="483381">
                  <a:extLst>
                    <a:ext uri="{9D8B030D-6E8A-4147-A177-3AD203B41FA5}">
                      <a16:colId xmlns:a16="http://schemas.microsoft.com/office/drawing/2014/main" xmlns="" val="1870204054"/>
                    </a:ext>
                  </a:extLst>
                </a:gridCol>
                <a:gridCol w="859536">
                  <a:extLst>
                    <a:ext uri="{9D8B030D-6E8A-4147-A177-3AD203B41FA5}">
                      <a16:colId xmlns:a16="http://schemas.microsoft.com/office/drawing/2014/main" xmlns="" val="3571531918"/>
                    </a:ext>
                  </a:extLst>
                </a:gridCol>
                <a:gridCol w="1353312">
                  <a:extLst>
                    <a:ext uri="{9D8B030D-6E8A-4147-A177-3AD203B41FA5}">
                      <a16:colId xmlns:a16="http://schemas.microsoft.com/office/drawing/2014/main" xmlns="" val="4088979873"/>
                    </a:ext>
                  </a:extLst>
                </a:gridCol>
                <a:gridCol w="4620186">
                  <a:extLst>
                    <a:ext uri="{9D8B030D-6E8A-4147-A177-3AD203B41FA5}">
                      <a16:colId xmlns:a16="http://schemas.microsoft.com/office/drawing/2014/main" xmlns="" val="120783647"/>
                    </a:ext>
                  </a:extLst>
                </a:gridCol>
                <a:gridCol w="857250">
                  <a:extLst>
                    <a:ext uri="{9D8B030D-6E8A-4147-A177-3AD203B41FA5}">
                      <a16:colId xmlns:a16="http://schemas.microsoft.com/office/drawing/2014/main" xmlns="" val="3270725404"/>
                    </a:ext>
                  </a:extLst>
                </a:gridCol>
                <a:gridCol w="1162050">
                  <a:extLst>
                    <a:ext uri="{9D8B030D-6E8A-4147-A177-3AD203B41FA5}">
                      <a16:colId xmlns:a16="http://schemas.microsoft.com/office/drawing/2014/main" xmlns="" val="3683565691"/>
                    </a:ext>
                  </a:extLst>
                </a:gridCol>
                <a:gridCol w="781050">
                  <a:extLst>
                    <a:ext uri="{9D8B030D-6E8A-4147-A177-3AD203B41FA5}">
                      <a16:colId xmlns:a16="http://schemas.microsoft.com/office/drawing/2014/main" xmlns="" val="3525253308"/>
                    </a:ext>
                  </a:extLst>
                </a:gridCol>
                <a:gridCol w="864263">
                  <a:extLst>
                    <a:ext uri="{9D8B030D-6E8A-4147-A177-3AD203B41FA5}">
                      <a16:colId xmlns:a16="http://schemas.microsoft.com/office/drawing/2014/main" xmlns="" val="2749235395"/>
                    </a:ext>
                  </a:extLst>
                </a:gridCol>
              </a:tblGrid>
              <a:tr h="404646">
                <a:tc rowSpan="2" gridSpan="2">
                  <a:txBody>
                    <a:bodyPr/>
                    <a:lstStyle/>
                    <a:p>
                      <a:pPr algn="l" latinLnBrk="1">
                        <a:lnSpc>
                          <a:spcPct val="80000"/>
                        </a:lnSpc>
                      </a:pPr>
                      <a:r>
                        <a:rPr lang="en-US" altLang="ko-KR" sz="20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        </a:t>
                      </a: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udy 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 hMerge="1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FS/ME</a:t>
                      </a:r>
                      <a:r>
                        <a:rPr lang="en-US" altLang="ko-KR" sz="1500" baseline="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ases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ses of</a:t>
                      </a:r>
                      <a:r>
                        <a:rPr lang="en-US" altLang="ko-KR" sz="1500" baseline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Oxford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cidence Rate (%)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te (%) 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%-CI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ight %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506282246"/>
                  </a:ext>
                </a:extLst>
              </a:tr>
              <a:tr h="404646">
                <a:tc gridSpan="2"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xed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ndom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65054661"/>
                  </a:ext>
                </a:extLst>
              </a:tr>
              <a:tr h="301176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Lindal</a:t>
                      </a:r>
                      <a:r>
                        <a:rPr lang="en-US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2 [34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4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20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6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7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3.05;</a:t>
                      </a:r>
                      <a:r>
                        <a:rPr lang="en-US" altLang="ko-KR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.57]    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0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102593090"/>
                  </a:ext>
                </a:extLst>
              </a:tr>
              <a:tr h="301176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Wessely</a:t>
                      </a:r>
                      <a:r>
                        <a:rPr lang="en-US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7 [16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85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22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1.65; 2.98]      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898440909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Lawrie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nd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Pelosi,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995 [60]</a:t>
                      </a: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95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8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22; 1.53]   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180887130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ates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993 [39]</a:t>
                      </a: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95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40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15;</a:t>
                      </a:r>
                      <a:r>
                        <a:rPr lang="en-US" altLang="ko-KR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7]    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029290213"/>
                  </a:ext>
                </a:extLst>
              </a:tr>
              <a:tr h="376504">
                <a:tc gridSpan="2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en-US" altLang="ko-KR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endParaRPr lang="en-US" altLang="ko-KR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r>
                        <a:rPr lang="en-US" altLang="ko-KR" sz="15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xed </a:t>
                      </a:r>
                      <a:r>
                        <a:rPr lang="en-US" altLang="ko-KR" sz="15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ffect model </a:t>
                      </a:r>
                      <a:endParaRPr lang="ko-KR" altLang="en-US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2.85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2.42; 3.35]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.0%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-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014201241"/>
                  </a:ext>
                </a:extLst>
              </a:tr>
              <a:tr h="346364">
                <a:tc gridSpan="3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endParaRPr lang="en-US" altLang="ko-KR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r>
                        <a:rPr lang="en-US" altLang="ko-KR" sz="15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ndom</a:t>
                      </a:r>
                      <a:r>
                        <a:rPr lang="en-US" altLang="ko-KR" sz="1500" b="1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effects model</a:t>
                      </a:r>
                      <a:endParaRPr lang="ko-KR" altLang="en-US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sz="10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1</a:t>
                      </a:r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0.68; 2.93]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-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.0%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275093605"/>
                  </a:ext>
                </a:extLst>
              </a:tr>
              <a:tr h="556781"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r>
                        <a:rPr lang="en-US" altLang="ko-KR" sz="15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terogeneity </a:t>
                      </a:r>
                      <a:endParaRPr lang="ko-KR" altLang="en-US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latinLnBrk="1">
                        <a:lnSpc>
                          <a:spcPct val="80000"/>
                        </a:lnSpc>
                      </a:pPr>
                      <a:r>
                        <a:rPr lang="en-US" altLang="ko-KR" sz="1500" i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I</a:t>
                      </a:r>
                      <a:r>
                        <a:rPr lang="en-US" altLang="ko-KR" sz="1500" baseline="300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= 91.5%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latinLnBrk="1">
                        <a:lnSpc>
                          <a:spcPct val="80000"/>
                        </a:lnSpc>
                      </a:pPr>
                      <a:r>
                        <a:rPr lang="en-US" altLang="ko-KR" sz="1500" i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</a:t>
                      </a:r>
                      <a:r>
                        <a:rPr lang="en-US" altLang="ko-KR" sz="1500" baseline="300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= 0.4468</a:t>
                      </a:r>
                    </a:p>
                    <a:p>
                      <a:pPr marL="0" marR="0" lvl="0" indent="0" algn="l" defTabSz="1320759" rtl="0" eaLnBrk="1" fontAlgn="auto" latinLnBrk="1" hangingPunct="1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500" i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&lt;0.01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838004142"/>
                  </a:ext>
                </a:extLst>
              </a:tr>
            </a:tbl>
          </a:graphicData>
        </a:graphic>
      </p:graphicFrame>
      <p:graphicFrame>
        <p:nvGraphicFramePr>
          <p:cNvPr id="13" name="표 1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1434292028"/>
              </p:ext>
            </p:extLst>
          </p:nvPr>
        </p:nvGraphicFramePr>
        <p:xfrm>
          <a:off x="86770" y="14301152"/>
          <a:ext cx="12834550" cy="3216871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143258">
                  <a:extLst>
                    <a:ext uri="{9D8B030D-6E8A-4147-A177-3AD203B41FA5}">
                      <a16:colId xmlns:a16="http://schemas.microsoft.com/office/drawing/2014/main" xmlns="" val="1409189042"/>
                    </a:ext>
                  </a:extLst>
                </a:gridCol>
                <a:gridCol w="1078992">
                  <a:extLst>
                    <a:ext uri="{9D8B030D-6E8A-4147-A177-3AD203B41FA5}">
                      <a16:colId xmlns:a16="http://schemas.microsoft.com/office/drawing/2014/main" xmlns="" val="3571531918"/>
                    </a:ext>
                  </a:extLst>
                </a:gridCol>
                <a:gridCol w="1152144">
                  <a:extLst>
                    <a:ext uri="{9D8B030D-6E8A-4147-A177-3AD203B41FA5}">
                      <a16:colId xmlns:a16="http://schemas.microsoft.com/office/drawing/2014/main" xmlns="" val="4088979873"/>
                    </a:ext>
                  </a:extLst>
                </a:gridCol>
                <a:gridCol w="4795543">
                  <a:extLst>
                    <a:ext uri="{9D8B030D-6E8A-4147-A177-3AD203B41FA5}">
                      <a16:colId xmlns:a16="http://schemas.microsoft.com/office/drawing/2014/main" xmlns="" val="120783647"/>
                    </a:ext>
                  </a:extLst>
                </a:gridCol>
                <a:gridCol w="857250">
                  <a:extLst>
                    <a:ext uri="{9D8B030D-6E8A-4147-A177-3AD203B41FA5}">
                      <a16:colId xmlns:a16="http://schemas.microsoft.com/office/drawing/2014/main" xmlns="" val="3270725404"/>
                    </a:ext>
                  </a:extLst>
                </a:gridCol>
                <a:gridCol w="1162050">
                  <a:extLst>
                    <a:ext uri="{9D8B030D-6E8A-4147-A177-3AD203B41FA5}">
                      <a16:colId xmlns:a16="http://schemas.microsoft.com/office/drawing/2014/main" xmlns="" val="3683565691"/>
                    </a:ext>
                  </a:extLst>
                </a:gridCol>
                <a:gridCol w="781050">
                  <a:extLst>
                    <a:ext uri="{9D8B030D-6E8A-4147-A177-3AD203B41FA5}">
                      <a16:colId xmlns:a16="http://schemas.microsoft.com/office/drawing/2014/main" xmlns="" val="3525253308"/>
                    </a:ext>
                  </a:extLst>
                </a:gridCol>
                <a:gridCol w="864263">
                  <a:extLst>
                    <a:ext uri="{9D8B030D-6E8A-4147-A177-3AD203B41FA5}">
                      <a16:colId xmlns:a16="http://schemas.microsoft.com/office/drawing/2014/main" xmlns="" val="2749235395"/>
                    </a:ext>
                  </a:extLst>
                </a:gridCol>
              </a:tblGrid>
              <a:tr h="404646">
                <a:tc rowSpan="2">
                  <a:txBody>
                    <a:bodyPr/>
                    <a:lstStyle/>
                    <a:p>
                      <a:pPr algn="l" latinLnBrk="1">
                        <a:lnSpc>
                          <a:spcPct val="80000"/>
                        </a:lnSpc>
                      </a:pPr>
                      <a:r>
                        <a:rPr lang="en-US" altLang="ko-KR" sz="20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.         </a:t>
                      </a: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udy 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FS/ME</a:t>
                      </a:r>
                      <a:r>
                        <a:rPr lang="en-US" altLang="ko-KR" sz="1500" baseline="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ases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ses of</a:t>
                      </a:r>
                      <a:r>
                        <a:rPr lang="en-US" altLang="ko-KR" sz="1500" baseline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Others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cidence Rate (%)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te (%) 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%-CI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ight %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506282246"/>
                  </a:ext>
                </a:extLst>
              </a:tr>
              <a:tr h="40464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xed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ndom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65054661"/>
                  </a:ext>
                </a:extLst>
              </a:tr>
              <a:tr h="301176">
                <a:tc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ollin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016 [38]</a:t>
                      </a: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396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6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86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1.61;</a:t>
                      </a:r>
                      <a:r>
                        <a:rPr lang="en-US" altLang="ko-KR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2.14]</a:t>
                      </a: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6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102593090"/>
                  </a:ext>
                </a:extLst>
              </a:tr>
              <a:tr h="301176">
                <a:tc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acul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011 [37]</a:t>
                      </a: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6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315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09; 0.12] 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898440909"/>
                  </a:ext>
                </a:extLst>
              </a:tr>
              <a:tr h="296563">
                <a:tc>
                  <a:txBody>
                    <a:bodyPr/>
                    <a:lstStyle/>
                    <a:p>
                      <a:pPr marL="0" marR="0" lvl="0" indent="0" algn="l" defTabSz="990570" rtl="0" eaLnBrk="1" fontAlgn="ctr" latinLnBrk="1" hangingPunct="1">
                        <a:lnSpc>
                          <a:spcPct val="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acul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011 [37]</a:t>
                      </a: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315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02; 0.04]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180887130"/>
                  </a:ext>
                </a:extLst>
              </a:tr>
              <a:tr h="296563">
                <a:tc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Ho-yen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nd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Mc,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991 [36]</a:t>
                      </a: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899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12; 0.15]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029290213"/>
                  </a:ext>
                </a:extLst>
              </a:tr>
              <a:tr h="283166">
                <a:tc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en-US" altLang="ko-KR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endParaRPr lang="en-US" altLang="ko-KR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r>
                        <a:rPr lang="en-US" altLang="ko-KR" sz="15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xed </a:t>
                      </a:r>
                      <a:r>
                        <a:rPr lang="en-US" altLang="ko-KR" sz="15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ffect model </a:t>
                      </a:r>
                      <a:endParaRPr lang="ko-KR" altLang="en-US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4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0.22; 0.26]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.0%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-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014201241"/>
                  </a:ext>
                </a:extLst>
              </a:tr>
              <a:tr h="241201">
                <a:tc gridSpan="2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endParaRPr lang="en-US" altLang="ko-KR" sz="15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r>
                        <a:rPr lang="en-US" altLang="ko-KR" sz="15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ndom</a:t>
                      </a:r>
                      <a:r>
                        <a:rPr lang="en-US" altLang="ko-KR" sz="1500" b="1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b="1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ffects model</a:t>
                      </a:r>
                      <a:endParaRPr lang="ko-KR" altLang="en-US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7</a:t>
                      </a: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</a:t>
                      </a: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; 0.83]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-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.0</a:t>
                      </a: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150799850"/>
                  </a:ext>
                </a:extLst>
              </a:tr>
              <a:tr h="556781"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r>
                        <a:rPr lang="en-US" altLang="ko-KR" sz="15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terogeneity </a:t>
                      </a:r>
                      <a:endParaRPr lang="ko-KR" altLang="en-US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1320759" rtl="0" eaLnBrk="1" fontAlgn="auto" latinLnBrk="1" hangingPunct="1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500" i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I</a:t>
                      </a:r>
                      <a:r>
                        <a:rPr lang="en-US" altLang="ko-KR" sz="1500" baseline="300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=99.8%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 latinLnBrk="1">
                        <a:lnSpc>
                          <a:spcPct val="80000"/>
                        </a:lnSpc>
                      </a:pP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latinLnBrk="1">
                        <a:lnSpc>
                          <a:spcPct val="80000"/>
                        </a:lnSpc>
                      </a:pPr>
                      <a:r>
                        <a:rPr lang="en-US" altLang="ko-KR" sz="1500" i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</a:t>
                      </a:r>
                      <a:r>
                        <a:rPr lang="en-US" altLang="ko-KR" sz="1500" baseline="300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= 2.5864</a:t>
                      </a:r>
                    </a:p>
                    <a:p>
                      <a:pPr marL="0" marR="0" lvl="0" indent="0" algn="l" defTabSz="1320759" rtl="0" eaLnBrk="1" fontAlgn="auto" latinLnBrk="1" hangingPunct="1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500" i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&lt;0.01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838004142"/>
                  </a:ext>
                </a:extLst>
              </a:tr>
            </a:tbl>
          </a:graphicData>
        </a:graphic>
      </p:graphicFrame>
      <p:grpSp>
        <p:nvGrpSpPr>
          <p:cNvPr id="14" name="그룹 13"/>
          <p:cNvGrpSpPr/>
          <p:nvPr/>
        </p:nvGrpSpPr>
        <p:grpSpPr>
          <a:xfrm>
            <a:off x="4339520" y="2631887"/>
            <a:ext cx="5888227" cy="3672364"/>
            <a:chOff x="4151122" y="2746187"/>
            <a:chExt cx="5888227" cy="3672364"/>
          </a:xfrm>
        </p:grpSpPr>
        <p:pic>
          <p:nvPicPr>
            <p:cNvPr id="22" name="그림 21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4355349" y="2746187"/>
              <a:ext cx="4962330" cy="2997580"/>
            </a:xfrm>
            <a:prstGeom prst="rect">
              <a:avLst/>
            </a:prstGeom>
          </p:spPr>
        </p:pic>
        <p:grpSp>
          <p:nvGrpSpPr>
            <p:cNvPr id="23" name="그룹 22"/>
            <p:cNvGrpSpPr/>
            <p:nvPr/>
          </p:nvGrpSpPr>
          <p:grpSpPr>
            <a:xfrm>
              <a:off x="4151122" y="5955700"/>
              <a:ext cx="5888227" cy="462851"/>
              <a:chOff x="4151122" y="5955700"/>
              <a:chExt cx="5888227" cy="462851"/>
            </a:xfrm>
          </p:grpSpPr>
          <p:pic>
            <p:nvPicPr>
              <p:cNvPr id="24" name="그림 23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tretch>
                <a:fillRect/>
              </a:stretch>
            </p:blipFill>
            <p:spPr>
              <a:xfrm>
                <a:off x="4342303" y="5955700"/>
                <a:ext cx="5045122" cy="199843"/>
              </a:xfrm>
              <a:prstGeom prst="rect">
                <a:avLst/>
              </a:prstGeom>
            </p:spPr>
          </p:pic>
          <p:sp>
            <p:nvSpPr>
              <p:cNvPr id="25" name="TextBox 24"/>
              <p:cNvSpPr txBox="1"/>
              <p:nvPr/>
            </p:nvSpPr>
            <p:spPr>
              <a:xfrm>
                <a:off x="4151122" y="6100002"/>
                <a:ext cx="5888227" cy="3185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7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0.0                      0.5                      1.0                     1.5                      2.0 (%)  </a:t>
                </a:r>
                <a:endParaRPr lang="ko-KR" altLang="en-US" sz="147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26" name="그룹 25"/>
          <p:cNvGrpSpPr/>
          <p:nvPr/>
        </p:nvGrpSpPr>
        <p:grpSpPr>
          <a:xfrm>
            <a:off x="4348293" y="7525533"/>
            <a:ext cx="5379815" cy="2464351"/>
            <a:chOff x="4459129" y="7639833"/>
            <a:chExt cx="5379815" cy="2464351"/>
          </a:xfrm>
        </p:grpSpPr>
        <p:pic>
          <p:nvPicPr>
            <p:cNvPr id="27" name="그림 26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4547431" y="7639833"/>
              <a:ext cx="5069481" cy="1827845"/>
            </a:xfrm>
            <a:prstGeom prst="rect">
              <a:avLst/>
            </a:prstGeom>
          </p:spPr>
        </p:pic>
        <p:grpSp>
          <p:nvGrpSpPr>
            <p:cNvPr id="28" name="그룹 27"/>
            <p:cNvGrpSpPr/>
            <p:nvPr/>
          </p:nvGrpSpPr>
          <p:grpSpPr>
            <a:xfrm>
              <a:off x="4459129" y="9651236"/>
              <a:ext cx="5379815" cy="452948"/>
              <a:chOff x="4332805" y="9689336"/>
              <a:chExt cx="5826437" cy="452948"/>
            </a:xfrm>
          </p:grpSpPr>
          <p:sp>
            <p:nvSpPr>
              <p:cNvPr id="29" name="TextBox 28"/>
              <p:cNvSpPr txBox="1"/>
              <p:nvPr/>
            </p:nvSpPr>
            <p:spPr>
              <a:xfrm>
                <a:off x="4332805" y="9823735"/>
                <a:ext cx="5826437" cy="3185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7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0.0           2.0            4.0           6.0           8.0           10.0          12.0 (%)           </a:t>
                </a:r>
                <a:endParaRPr lang="ko-KR" altLang="en-US" sz="147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30" name="그림 29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tretch>
                <a:fillRect/>
              </a:stretch>
            </p:blipFill>
            <p:spPr>
              <a:xfrm>
                <a:off x="4512705" y="9689336"/>
                <a:ext cx="5045122" cy="199843"/>
              </a:xfrm>
              <a:prstGeom prst="rect">
                <a:avLst/>
              </a:prstGeom>
            </p:spPr>
          </p:pic>
        </p:grpSp>
      </p:grpSp>
      <p:grpSp>
        <p:nvGrpSpPr>
          <p:cNvPr id="31" name="그룹 30"/>
          <p:cNvGrpSpPr/>
          <p:nvPr/>
        </p:nvGrpSpPr>
        <p:grpSpPr>
          <a:xfrm>
            <a:off x="4300128" y="11077505"/>
            <a:ext cx="5723467" cy="2549320"/>
            <a:chOff x="4246372" y="11191805"/>
            <a:chExt cx="5723467" cy="2549320"/>
          </a:xfrm>
        </p:grpSpPr>
        <p:pic>
          <p:nvPicPr>
            <p:cNvPr id="32" name="그림 31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4506591" y="11191805"/>
              <a:ext cx="3758652" cy="2013597"/>
            </a:xfrm>
            <a:prstGeom prst="rect">
              <a:avLst/>
            </a:prstGeom>
          </p:spPr>
        </p:pic>
        <p:grpSp>
          <p:nvGrpSpPr>
            <p:cNvPr id="33" name="그룹 32"/>
            <p:cNvGrpSpPr/>
            <p:nvPr/>
          </p:nvGrpSpPr>
          <p:grpSpPr>
            <a:xfrm>
              <a:off x="4246372" y="13290598"/>
              <a:ext cx="5723467" cy="450527"/>
              <a:chOff x="3195268" y="18088860"/>
              <a:chExt cx="5723467" cy="450527"/>
            </a:xfrm>
          </p:grpSpPr>
          <p:sp>
            <p:nvSpPr>
              <p:cNvPr id="34" name="TextBox 33"/>
              <p:cNvSpPr txBox="1"/>
              <p:nvPr/>
            </p:nvSpPr>
            <p:spPr>
              <a:xfrm>
                <a:off x="3195268" y="18220838"/>
                <a:ext cx="5723467" cy="3185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7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0.0            1.0            2.0           3.0           4.0            5.0            6.0 (%) </a:t>
                </a:r>
                <a:endParaRPr lang="ko-KR" altLang="en-US" sz="147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35" name="그림 34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tretch>
                <a:fillRect/>
              </a:stretch>
            </p:blipFill>
            <p:spPr>
              <a:xfrm>
                <a:off x="3398120" y="18088860"/>
                <a:ext cx="4749402" cy="196996"/>
              </a:xfrm>
              <a:prstGeom prst="rect">
                <a:avLst/>
              </a:prstGeom>
            </p:spPr>
          </p:pic>
        </p:grpSp>
      </p:grpSp>
      <p:grpSp>
        <p:nvGrpSpPr>
          <p:cNvPr id="36" name="그룹 35"/>
          <p:cNvGrpSpPr/>
          <p:nvPr/>
        </p:nvGrpSpPr>
        <p:grpSpPr>
          <a:xfrm>
            <a:off x="4230884" y="15050421"/>
            <a:ext cx="6355281" cy="2338164"/>
            <a:chOff x="4030824" y="15050421"/>
            <a:chExt cx="6355281" cy="2338164"/>
          </a:xfrm>
        </p:grpSpPr>
        <p:pic>
          <p:nvPicPr>
            <p:cNvPr id="37" name="그림 36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4225963" y="15050421"/>
              <a:ext cx="4971418" cy="1774804"/>
            </a:xfrm>
            <a:prstGeom prst="rect">
              <a:avLst/>
            </a:prstGeom>
          </p:spPr>
        </p:pic>
        <p:grpSp>
          <p:nvGrpSpPr>
            <p:cNvPr id="38" name="그룹 37"/>
            <p:cNvGrpSpPr/>
            <p:nvPr/>
          </p:nvGrpSpPr>
          <p:grpSpPr>
            <a:xfrm>
              <a:off x="4030824" y="16973237"/>
              <a:ext cx="6355281" cy="415348"/>
              <a:chOff x="3127394" y="18349910"/>
              <a:chExt cx="6355281" cy="450527"/>
            </a:xfrm>
          </p:grpSpPr>
          <p:sp>
            <p:nvSpPr>
              <p:cNvPr id="39" name="TextBox 38"/>
              <p:cNvSpPr txBox="1"/>
              <p:nvPr/>
            </p:nvSpPr>
            <p:spPr>
              <a:xfrm>
                <a:off x="3127394" y="18481888"/>
                <a:ext cx="6355281" cy="3185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7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0.0                    0.5                    1.0                    1.5                    2.0 (%) </a:t>
                </a:r>
                <a:endParaRPr lang="ko-KR" altLang="en-US" sz="147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40" name="그림 39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tretch>
                <a:fillRect/>
              </a:stretch>
            </p:blipFill>
            <p:spPr>
              <a:xfrm>
                <a:off x="3330246" y="18349910"/>
                <a:ext cx="4749402" cy="196996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xmlns="" val="42807161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70</TotalTime>
  <Words>649</Words>
  <Application>Microsoft Office PowerPoint</Application>
  <PresentationFormat>Custom</PresentationFormat>
  <Paragraphs>52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테마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0016236</cp:lastModifiedBy>
  <cp:revision>21</cp:revision>
  <cp:lastPrinted>2020-01-02T00:55:33Z</cp:lastPrinted>
  <dcterms:created xsi:type="dcterms:W3CDTF">2019-12-30T09:07:39Z</dcterms:created>
  <dcterms:modified xsi:type="dcterms:W3CDTF">2020-02-15T03:26:05Z</dcterms:modified>
</cp:coreProperties>
</file>